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42223"/>
    <a:srgbClr val="27232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-2604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1B20C-C081-486B-8847-0A8F517DF7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59D4D9-E4DC-4F11-A473-FC939D860E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421328-F33A-4442-82C8-7BFDC4430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631156-CE8B-4C9F-A09E-F40A268FD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746306-E01C-48CD-8FD1-8DD1DF8F7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838323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1FE7B0-6782-4249-9FA3-AC727753F1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3FD677-FB51-439C-917E-5D04DBD08A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58B88-87A8-4780-9953-5C27D2E96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8B0238-698E-430D-91BE-703448C1C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5C6F5B-8E7F-4F47-969B-052D86593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67234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CBD032-6510-4BC7-B95E-A9058BDE63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FE8079-8B38-4316-AA49-934B432D54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62B47A-55B5-4892-808E-0B5A06E10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98DCE-3D4F-403B-B8FB-DD993F920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73ED89-FD81-4B53-A53B-A12A16CA6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94135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33E5CE-C147-4D70-B0CD-9AEED00EEB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D8DCEE-DC20-4A33-B436-C5AE0159B0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CC359A-7D4F-49C4-B290-539EB0179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56B410-6EE1-4F30-A14B-A91E82345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D86FA5-4A61-4DDB-85D8-AB6B9A2B4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32052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FC640A-E1E9-4CD4-951C-C221919EAD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A1EA2C-4E00-4C5E-A368-EFD9965933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7DA9EC-2707-4D1D-AF8C-C381410C6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25E6DC-3DF3-433E-8B8F-FD9A84144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0F70D0-758C-4DD2-AE95-9E29E0C5F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08720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0B0369-6488-4972-9A96-B9214C2B8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1D6158-2868-4D72-8536-DB5C68F344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E93A4B-9867-4336-AAB5-B8ECEEFEC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E6A560-FFB3-4A71-BDD7-8D830549F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5FE088-1FAC-4939-A3C8-2E51C1819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B944A9-5DF8-498A-8B1D-9A97CAA29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979326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F848AB-4F34-4171-AEDF-D7F0C8067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5004C1-4834-48A8-8525-AFBD41E881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475A19-5B65-4D72-9913-E896294502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AB3DFC-057B-494F-950A-9AD2B794E3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48D702-42BF-4578-86F6-F722F29EFA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4D1BEF-2F17-4E76-9FDD-08D39FF28A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173B1D-521E-48BD-B860-99FFA08E2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B7554C-7974-4945-AAA6-E0CCDE5C1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6511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10124F-6D95-4639-BEA9-831CC6319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DCEF57-789D-42CD-BEC0-588CE7CB5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C4C2AA-D7DA-45B4-B614-38FC25FD6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BE281D-C536-4BEF-B9B9-E61552972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124748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FA2E95-BC42-4E5F-B058-42780591F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2C41BC-6D4B-4089-B8F5-780E50CE3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01E045-BB52-4057-8B55-B63EF1FC2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88022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1E7287-7ACA-4D07-88E7-CE5458B3CF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2B5B89-27BE-4313-81CC-90785E1B9A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B2CB19-EC70-416A-95DD-2FE75DF608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DEF5FA-1EB5-4C07-ACF6-E15053256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A92572-E6FB-429F-B64B-5F762C48E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51CC28-445A-45F6-9A71-17BACE78E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858992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83D6D8-1F09-409E-B438-EA0526D04C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3DD14D-12BD-474E-B0D1-29572CD61D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44EE01-4144-49D7-A859-05AA9EF5C9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641D0D-47F8-4BE6-A70C-66A6DA78D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0865BD-32A5-4BED-A747-8D5E5B01F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2951DD-F73A-468A-8D76-923F0C4B9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440978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1906019-043D-40EF-A405-4BFFE00FB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FD3CD6-6716-4D1F-9883-102705519A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B50186-A246-4B6A-9268-7FAC394674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53A1B-E2C3-4276-863F-1191D1963B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5FCB68-7CD8-45CE-B59D-1D9B6E2A94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4142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09F5BC-F6B9-47A7-9698-182376D13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Additional Fil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A2747A2-FCAF-40C7-AFFA-0845CB4D6012}"/>
              </a:ext>
            </a:extLst>
          </p:cNvPr>
          <p:cNvSpPr txBox="1"/>
          <p:nvPr/>
        </p:nvSpPr>
        <p:spPr>
          <a:xfrm>
            <a:off x="7034457" y="3034711"/>
            <a:ext cx="3452656" cy="21828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4000"/>
              </a:lnSpc>
              <a:spcAft>
                <a:spcPts val="1000"/>
              </a:spcAft>
            </a:pPr>
            <a:r>
              <a:rPr lang="en-SG" sz="1000" b="1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Additional File 2. Mechanistic </a:t>
            </a:r>
            <a:r>
              <a:rPr lang="en-SG" sz="10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Model of the habenula-mediated DR response</a:t>
            </a:r>
            <a:r>
              <a:rPr lang="en-SG" sz="10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. The different arrow heads can either represent activation ( </a:t>
            </a:r>
            <a:r>
              <a:rPr lang="en-SG" sz="10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→</a:t>
            </a:r>
            <a:r>
              <a:rPr lang="en-SG" sz="10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) or inhibition ( ―| ). For example A</a:t>
            </a:r>
            <a:r>
              <a:rPr lang="zh-TW" sz="10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→</a:t>
            </a:r>
            <a:r>
              <a:rPr lang="en-SG" sz="10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B means that A activates B. C </a:t>
            </a:r>
            <a:r>
              <a:rPr lang="zh-TW" sz="10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→</a:t>
            </a:r>
            <a:r>
              <a:rPr lang="en-SG" sz="10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 (A ―| B) means that C is necessary for the ability of A to inhibit B. (A) The necessary starting information for our mechanistic </a:t>
            </a:r>
            <a:r>
              <a:rPr lang="en-SG" sz="1000" dirty="0" err="1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modeling</a:t>
            </a:r>
            <a:r>
              <a:rPr lang="en-SG" sz="10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, based on anatomical connections, prior literature, and our definition of ON and OFF cells. (B) Our candidate mechanistic model. The arrow from D-on to the raphe is bold to represent that its effect is stronger than the opposite influence from V-on to the raphe. (C) ODE equations for our candidate model shown in panel B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5EFB1D62-FDAE-4FB6-ABF4-BBB7E55E4D9A}"/>
              </a:ext>
            </a:extLst>
          </p:cNvPr>
          <p:cNvGrpSpPr/>
          <p:nvPr/>
        </p:nvGrpSpPr>
        <p:grpSpPr>
          <a:xfrm>
            <a:off x="376727" y="1409722"/>
            <a:ext cx="5791044" cy="5434180"/>
            <a:chOff x="443216" y="1998779"/>
            <a:chExt cx="5791044" cy="543418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5CD8CA7-4748-46B9-BAFA-C17D84AFDBA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3216" y="1998779"/>
              <a:ext cx="5791044" cy="2908969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405D5A0D-FAE3-4796-B88D-A39DF3AC82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66543" y="5474783"/>
              <a:ext cx="4686010" cy="1958176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05CF5ED8-FFEB-4A8D-8C5D-017F401DB4DF}"/>
                </a:ext>
              </a:extLst>
            </p:cNvPr>
            <p:cNvSpPr/>
            <p:nvPr/>
          </p:nvSpPr>
          <p:spPr>
            <a:xfrm>
              <a:off x="488228" y="2019947"/>
              <a:ext cx="471340" cy="4095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SG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A6513D3A-9592-433E-9378-0E304D96E7F9}"/>
                </a:ext>
              </a:extLst>
            </p:cNvPr>
            <p:cNvSpPr/>
            <p:nvPr/>
          </p:nvSpPr>
          <p:spPr>
            <a:xfrm>
              <a:off x="3103068" y="2019947"/>
              <a:ext cx="471340" cy="4095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SG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647D5EA-3607-473D-BC60-745B6A9067B9}"/>
                </a:ext>
              </a:extLst>
            </p:cNvPr>
            <p:cNvSpPr/>
            <p:nvPr/>
          </p:nvSpPr>
          <p:spPr>
            <a:xfrm>
              <a:off x="1106804" y="4911786"/>
              <a:ext cx="471340" cy="4095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SG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45142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752</TotalTime>
  <Words>142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dditional File 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rendra Suhas Jagannathan</dc:creator>
  <cp:lastModifiedBy>Narendra Suhas Jagannathan</cp:lastModifiedBy>
  <cp:revision>70</cp:revision>
  <dcterms:created xsi:type="dcterms:W3CDTF">2022-09-06T02:43:51Z</dcterms:created>
  <dcterms:modified xsi:type="dcterms:W3CDTF">2023-03-31T11:44:45Z</dcterms:modified>
</cp:coreProperties>
</file>